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60443D-7A37-4EBE-A14B-3454C36535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66A155-C842-43F1-B06B-7D619FABF7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537CA4-68B9-4A7D-B1C3-596C3A62E7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E30DE-A208-48AD-AFD9-C9DDFC88E1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A5D89-907C-4914-AA3A-7E72830254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1227D-A7A0-4BAD-8E51-214F8C0B0A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4DE23-E7E1-42C1-913B-6D2F08A848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36883-A848-4C8C-9F7A-B0D158BCE8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72442-6288-48B8-8F99-7CE47A6F17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B7CE6A-AA9F-4C99-97F5-8BDBF06234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A38BAB-1292-4DDE-AAC3-A37797DAAA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1BDD0-5BE3-476A-9928-1E5F38C18C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F10F27-E8C3-403D-A5F4-841058287D7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39640" y="333360"/>
            <a:ext cx="8939160" cy="611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ＭＳ ゴシック"/>
              </a:rPr>
              <a:t>Table 1.  HIV/SIV coreceptors and formylpeptide receptors with amino acid sequences of their NT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PCR                 Amino acid sequence                           Tyrosines in NTR   Ref.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Osaka−等幅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Osaka−等幅"/>
              </a:rPr>
              <a:t>                                                                                                                                                          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C-CKR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CR1               METPNTTE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TTTEF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DATPCQKVNERAFGA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　　　　　　　　　　　　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2      3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CR2b              MLSTSRSRFIRNTNESGEEVTTFF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APCHKFDVKQIGA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　　　　　　　　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2      1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CR3               MTTSLDTVETFGTTS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DVGLLCEKADTRALMA                    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　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2      1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CR5               M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QVSSPI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IN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SEPCQKINVKQIAA                            4       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CR8               M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LDLSVTTVT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Y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DIFSSPCDAELIQTNGK                       3      1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　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6                 MAATASPQPLATEDADSENSSF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Y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LDEVAFMLCRKDAVVSFGKVFLP        3      1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XC-CKR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XCR1              MSNITDPQMWDFDDLNFTGMPPADE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SPCMLETETLNK                   1      3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XCR2              MEDFNMESDSFEDFWKGEDLSN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S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SSTLPPFLLDAAPCEPESLEINK          2      3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XCR4              MEGISI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SDN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EEMGSG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SMKEPCFREENANFNKI                   3       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XCR5              MN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LTLEMDLENLEDLFWELDRLDN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DTSLVENHLCPATEGPLMASFKAVFVP   1      1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XCR6              MAEH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HE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FSSFNDSSQEEHQDFLQFSKV                          2      1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Other CKR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X3CR1             MDQFPESVTENFE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DLAEAC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IGDIVVFGT                           2      2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PCR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APJ                MEEGGDFDN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ADNQSECE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DWKS                                3      2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ChemR23            MRMEDE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NTSIS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DE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P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LDSIVVLEDLSPLEARVTRI                 4      2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PR1               MEDLEETLFEEFEN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S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DL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SLESDLEEK                           4      2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GPR15              MDPEETSV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L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Y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ATSPNSDIRETHSHVP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S                         5      2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RDC1               MDLHLFD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SEPGNFSDISWPCNSSDCIVVDTVMCPNMPNK                  1      2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Formylpeptide receptor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FPRL1              METNFSTPLNE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EEVS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ESAG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VLRI                               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FPRL2              METNFSIPLNETEEVLPEPAGHTVLWI                               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  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FPR1               METNSSLPTNISGGTPAVSAG</a:t>
            </a:r>
            <a:r>
              <a:rPr b="1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Y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LFLDI                               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*</a:t>
            </a:r>
            <a:r>
              <a:rPr b="0" lang="ja-JP" sz="1200" spc="-1" strike="noStrike">
                <a:solidFill>
                  <a:srgbClr val="000000"/>
                </a:solidFill>
                <a:latin typeface="ＭＳ ゴシック"/>
                <a:ea typeface="ＭＳ ゴシック"/>
              </a:rPr>
              <a:t>Tyrosine residues are shown in bold letter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611280" y="685800"/>
            <a:ext cx="678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11280" y="981000"/>
            <a:ext cx="678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11280" y="6165720"/>
            <a:ext cx="6781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1T07:35:14Z</dcterms:created>
  <dc:creator>清水宣明</dc:creator>
  <dc:description/>
  <dc:language>en-US</dc:language>
  <cp:lastModifiedBy>清水宣明</cp:lastModifiedBy>
  <dcterms:modified xsi:type="dcterms:W3CDTF">2008-05-14T02:22:53Z</dcterms:modified>
  <cp:revision>7</cp:revision>
  <dc:subject/>
  <dc:title>スライド タイトルなし</dc:title>
</cp:coreProperties>
</file>